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cs-CZ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72" d="100"/>
          <a:sy n="72" d="100"/>
        </p:scale>
        <p:origin x="-1242" y="19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Podnadpis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cs-CZ" smtClean="0"/>
              <a:t>Kliknutím lze upravit styl předlohy.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435476-2C2F-42C7-AE95-D447C2C4D39B}" type="datetimeFigureOut">
              <a:rPr lang="cs-CZ" smtClean="0"/>
              <a:t>14.1.2021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28663-3EF4-4B44-B7DE-739240FA615C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2849156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435476-2C2F-42C7-AE95-D447C2C4D39B}" type="datetimeFigureOut">
              <a:rPr lang="cs-CZ" smtClean="0"/>
              <a:t>14.1.2021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28663-3EF4-4B44-B7DE-739240FA615C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9739830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vislý nadpis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435476-2C2F-42C7-AE95-D447C2C4D39B}" type="datetimeFigureOut">
              <a:rPr lang="cs-CZ" smtClean="0"/>
              <a:t>14.1.2021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28663-3EF4-4B44-B7DE-739240FA615C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4888084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435476-2C2F-42C7-AE95-D447C2C4D39B}" type="datetimeFigureOut">
              <a:rPr lang="cs-CZ" smtClean="0"/>
              <a:t>14.1.2021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28663-3EF4-4B44-B7DE-739240FA615C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368334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čá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435476-2C2F-42C7-AE95-D447C2C4D39B}" type="datetimeFigureOut">
              <a:rPr lang="cs-CZ" smtClean="0"/>
              <a:t>14.1.2021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28663-3EF4-4B44-B7DE-739240FA615C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6428281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435476-2C2F-42C7-AE95-D447C2C4D39B}" type="datetimeFigureOut">
              <a:rPr lang="cs-CZ" smtClean="0"/>
              <a:t>14.1.2021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28663-3EF4-4B44-B7DE-739240FA615C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9422239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5" name="Zástupný symbol pro tex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6" name="Zástupný symbol pro obsah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7" name="Zástupný symbol pro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435476-2C2F-42C7-AE95-D447C2C4D39B}" type="datetimeFigureOut">
              <a:rPr lang="cs-CZ" smtClean="0"/>
              <a:t>14.1.2021</a:t>
            </a:fld>
            <a:endParaRPr lang="cs-CZ"/>
          </a:p>
        </p:txBody>
      </p:sp>
      <p:sp>
        <p:nvSpPr>
          <p:cNvPr id="8" name="Zástupný symbol pro zápatí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9" name="Zástupný symbol pro číslo snímk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28663-3EF4-4B44-B7DE-739240FA615C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0475301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Pouze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435476-2C2F-42C7-AE95-D447C2C4D39B}" type="datetimeFigureOut">
              <a:rPr lang="cs-CZ" smtClean="0"/>
              <a:t>14.1.2021</a:t>
            </a:fld>
            <a:endParaRPr lang="cs-CZ"/>
          </a:p>
        </p:txBody>
      </p:sp>
      <p:sp>
        <p:nvSpPr>
          <p:cNvPr id="4" name="Zástupný symbol pro zápatí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Zástupný symbol pro číslo snímk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28663-3EF4-4B44-B7DE-739240FA615C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1626697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435476-2C2F-42C7-AE95-D447C2C4D39B}" type="datetimeFigureOut">
              <a:rPr lang="cs-CZ" smtClean="0"/>
              <a:t>14.1.2021</a:t>
            </a:fld>
            <a:endParaRPr lang="cs-CZ"/>
          </a:p>
        </p:txBody>
      </p:sp>
      <p:sp>
        <p:nvSpPr>
          <p:cNvPr id="3" name="Zástupný symbol pro zápatí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Zástupný symbol pro číslo snímk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28663-3EF4-4B44-B7DE-739240FA615C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41455843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435476-2C2F-42C7-AE95-D447C2C4D39B}" type="datetimeFigureOut">
              <a:rPr lang="cs-CZ" smtClean="0"/>
              <a:t>14.1.2021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28663-3EF4-4B44-B7DE-739240FA615C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6192020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rázek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cs-CZ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435476-2C2F-42C7-AE95-D447C2C4D39B}" type="datetimeFigureOut">
              <a:rPr lang="cs-CZ" smtClean="0"/>
              <a:t>14.1.2021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28663-3EF4-4B44-B7DE-739240FA615C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2483001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nadpis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435476-2C2F-42C7-AE95-D447C2C4D39B}" type="datetimeFigureOut">
              <a:rPr lang="cs-CZ" smtClean="0"/>
              <a:t>14.1.2021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F28663-3EF4-4B44-B7DE-739240FA615C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832750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cs-CZ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Obrázek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24356" y="122592"/>
            <a:ext cx="6286500" cy="6286500"/>
          </a:xfrm>
          <a:prstGeom prst="rect">
            <a:avLst/>
          </a:prstGeom>
        </p:spPr>
      </p:pic>
      <p:sp>
        <p:nvSpPr>
          <p:cNvPr id="5" name="TextovéPole 4"/>
          <p:cNvSpPr txBox="1"/>
          <p:nvPr/>
        </p:nvSpPr>
        <p:spPr>
          <a:xfrm>
            <a:off x="137000" y="6078548"/>
            <a:ext cx="885698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b="1" smtClean="0">
                <a:latin typeface="Arial" panose="020B0604020202020204" pitchFamily="34" charset="0"/>
                <a:cs typeface="Arial" panose="020B0604020202020204" pitchFamily="34" charset="0"/>
              </a:rPr>
              <a:t>S4.</a:t>
            </a:r>
            <a:r>
              <a:rPr lang="en-US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BRIG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omparison of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NDM-1-encoding plasmid, p51015_NDM-1, characterized from an </a:t>
            </a:r>
            <a:r>
              <a:rPr lang="en-US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nterobacterales</a:t>
            </a:r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recovered from Czech hospital. </a:t>
            </a:r>
            <a:endParaRPr lang="cs-CZ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9531763"/>
      </p:ext>
    </p:extLst>
  </p:cSld>
  <p:clrMapOvr>
    <a:masterClrMapping/>
  </p:clrMapOvr>
</p:sld>
</file>

<file path=ppt/theme/theme1.xml><?xml version="1.0" encoding="utf-8"?>
<a:theme xmlns:a="http://schemas.openxmlformats.org/drawingml/2006/main" name="Motiv systému Office">
  <a:themeElements>
    <a:clrScheme name="Kancelář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celář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celář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20</Words>
  <Application>Microsoft Office PowerPoint</Application>
  <PresentationFormat>Předvádění na obrazovce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Motiv</vt:lpstr>
      </vt:variant>
      <vt:variant>
        <vt:i4>1</vt:i4>
      </vt:variant>
      <vt:variant>
        <vt:lpstr>Nadpisy snímků</vt:lpstr>
      </vt:variant>
      <vt:variant>
        <vt:i4>1</vt:i4>
      </vt:variant>
    </vt:vector>
  </HeadingPairs>
  <TitlesOfParts>
    <vt:vector size="2" baseType="lpstr">
      <vt:lpstr>Motiv systému Office</vt:lpstr>
      <vt:lpstr>Prezentace aplikac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papagiannitsis</dc:creator>
  <cp:lastModifiedBy>papagiannitsis</cp:lastModifiedBy>
  <cp:revision>3</cp:revision>
  <dcterms:created xsi:type="dcterms:W3CDTF">2020-10-22T06:35:57Z</dcterms:created>
  <dcterms:modified xsi:type="dcterms:W3CDTF">2021-01-14T11:03:15Z</dcterms:modified>
</cp:coreProperties>
</file>